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3657600" cy="7315200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A24B24-D6C7-4516-9B7D-7A0CC594BA30}" v="22" dt="2022-02-07T14:20:39.524"/>
    <p1510:client id="{FC26E2FD-89F9-9233-E79C-2A261B3F05A1}" v="17" dt="2022-02-07T14:23:39.2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76" d="100"/>
          <a:sy n="76" d="100"/>
        </p:scale>
        <p:origin x="148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udelman, Kelly Nicole Holohan" userId="S::kholohan@iu.edu::bad2640b-c1a5-43c5-b732-fde9e232756e" providerId="AD" clId="Web-{FC26E2FD-89F9-9233-E79C-2A261B3F05A1}"/>
    <pc:docChg chg="modSld">
      <pc:chgData name="Nudelman, Kelly Nicole Holohan" userId="S::kholohan@iu.edu::bad2640b-c1a5-43c5-b732-fde9e232756e" providerId="AD" clId="Web-{FC26E2FD-89F9-9233-E79C-2A261B3F05A1}" dt="2022-02-07T14:23:39.212" v="16" actId="1076"/>
      <pc:docMkLst>
        <pc:docMk/>
      </pc:docMkLst>
      <pc:sldChg chg="addSp modSp">
        <pc:chgData name="Nudelman, Kelly Nicole Holohan" userId="S::kholohan@iu.edu::bad2640b-c1a5-43c5-b732-fde9e232756e" providerId="AD" clId="Web-{FC26E2FD-89F9-9233-E79C-2A261B3F05A1}" dt="2022-02-07T14:23:39.212" v="16" actId="1076"/>
        <pc:sldMkLst>
          <pc:docMk/>
          <pc:sldMk cId="109857222" sldId="256"/>
        </pc:sldMkLst>
        <pc:spChg chg="add mod">
          <ac:chgData name="Nudelman, Kelly Nicole Holohan" userId="S::kholohan@iu.edu::bad2640b-c1a5-43c5-b732-fde9e232756e" providerId="AD" clId="Web-{FC26E2FD-89F9-9233-E79C-2A261B3F05A1}" dt="2022-02-07T14:23:26.243" v="15" actId="1076"/>
          <ac:spMkLst>
            <pc:docMk/>
            <pc:sldMk cId="109857222" sldId="256"/>
            <ac:spMk id="6" creationId="{614DAAE1-C538-4839-B905-9E9A300CB36D}"/>
          </ac:spMkLst>
        </pc:spChg>
        <pc:spChg chg="add mod">
          <ac:chgData name="Nudelman, Kelly Nicole Holohan" userId="S::kholohan@iu.edu::bad2640b-c1a5-43c5-b732-fde9e232756e" providerId="AD" clId="Web-{FC26E2FD-89F9-9233-E79C-2A261B3F05A1}" dt="2022-02-07T14:23:39.212" v="16" actId="1076"/>
          <ac:spMkLst>
            <pc:docMk/>
            <pc:sldMk cId="109857222" sldId="256"/>
            <ac:spMk id="7" creationId="{36261306-873B-444B-A42B-FAF44FB8BA76}"/>
          </ac:spMkLst>
        </pc:spChg>
        <pc:spChg chg="add mod">
          <ac:chgData name="Nudelman, Kelly Nicole Holohan" userId="S::kholohan@iu.edu::bad2640b-c1a5-43c5-b732-fde9e232756e" providerId="AD" clId="Web-{FC26E2FD-89F9-9233-E79C-2A261B3F05A1}" dt="2022-02-07T14:22:05.914" v="8" actId="1076"/>
          <ac:spMkLst>
            <pc:docMk/>
            <pc:sldMk cId="109857222" sldId="256"/>
            <ac:spMk id="8" creationId="{B1CF2514-160D-4953-9AE9-15296A6BCD56}"/>
          </ac:spMkLst>
        </pc:spChg>
        <pc:spChg chg="add mod">
          <ac:chgData name="Nudelman, Kelly Nicole Holohan" userId="S::kholohan@iu.edu::bad2640b-c1a5-43c5-b732-fde9e232756e" providerId="AD" clId="Web-{FC26E2FD-89F9-9233-E79C-2A261B3F05A1}" dt="2022-02-07T14:22:21.680" v="11" actId="1076"/>
          <ac:spMkLst>
            <pc:docMk/>
            <pc:sldMk cId="109857222" sldId="256"/>
            <ac:spMk id="9" creationId="{CF53D5A3-59EA-4C53-9ADA-B1179618D15D}"/>
          </ac:spMkLst>
        </pc:spChg>
      </pc:sldChg>
    </pc:docChg>
  </pc:docChgLst>
  <pc:docChgLst>
    <pc:chgData name="Nudelman, Kelly Nicole Holohan" userId="S::kholohan@iu.edu::bad2640b-c1a5-43c5-b732-fde9e232756e" providerId="AD" clId="Web-{E2A24B24-D6C7-4516-9B7D-7A0CC594BA30}"/>
    <pc:docChg chg="mod modSld addMainMaster delMainMaster modMainMaster setSldSz">
      <pc:chgData name="Nudelman, Kelly Nicole Holohan" userId="S::kholohan@iu.edu::bad2640b-c1a5-43c5-b732-fde9e232756e" providerId="AD" clId="Web-{E2A24B24-D6C7-4516-9B7D-7A0CC594BA30}" dt="2022-02-07T14:20:39.524" v="19" actId="1076"/>
      <pc:docMkLst>
        <pc:docMk/>
      </pc:docMkLst>
      <pc:sldChg chg="addSp delSp modSp mod modClrScheme chgLayout">
        <pc:chgData name="Nudelman, Kelly Nicole Holohan" userId="S::kholohan@iu.edu::bad2640b-c1a5-43c5-b732-fde9e232756e" providerId="AD" clId="Web-{E2A24B24-D6C7-4516-9B7D-7A0CC594BA30}" dt="2022-02-07T14:20:39.524" v="19" actId="1076"/>
        <pc:sldMkLst>
          <pc:docMk/>
          <pc:sldMk cId="109857222" sldId="256"/>
        </pc:sldMkLst>
        <pc:spChg chg="del">
          <ac:chgData name="Nudelman, Kelly Nicole Holohan" userId="S::kholohan@iu.edu::bad2640b-c1a5-43c5-b732-fde9e232756e" providerId="AD" clId="Web-{E2A24B24-D6C7-4516-9B7D-7A0CC594BA30}" dt="2022-02-07T14:18:35.181" v="0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Nudelman, Kelly Nicole Holohan" userId="S::kholohan@iu.edu::bad2640b-c1a5-43c5-b732-fde9e232756e" providerId="AD" clId="Web-{E2A24B24-D6C7-4516-9B7D-7A0CC594BA30}" dt="2022-02-07T14:18:35.181" v="0"/>
          <ac:spMkLst>
            <pc:docMk/>
            <pc:sldMk cId="109857222" sldId="256"/>
            <ac:spMk id="3" creationId="{00000000-0000-0000-0000-000000000000}"/>
          </ac:spMkLst>
        </pc:spChg>
        <pc:picChg chg="add mod">
          <ac:chgData name="Nudelman, Kelly Nicole Holohan" userId="S::kholohan@iu.edu::bad2640b-c1a5-43c5-b732-fde9e232756e" providerId="AD" clId="Web-{E2A24B24-D6C7-4516-9B7D-7A0CC594BA30}" dt="2022-02-07T14:20:22.383" v="15" actId="1076"/>
          <ac:picMkLst>
            <pc:docMk/>
            <pc:sldMk cId="109857222" sldId="256"/>
            <ac:picMk id="4" creationId="{30413DD4-CBF8-4C02-B6F5-D20E315B91BB}"/>
          </ac:picMkLst>
        </pc:picChg>
        <pc:picChg chg="add mod">
          <ac:chgData name="Nudelman, Kelly Nicole Holohan" userId="S::kholohan@iu.edu::bad2640b-c1a5-43c5-b732-fde9e232756e" providerId="AD" clId="Web-{E2A24B24-D6C7-4516-9B7D-7A0CC594BA30}" dt="2022-02-07T14:20:39.524" v="19" actId="1076"/>
          <ac:picMkLst>
            <pc:docMk/>
            <pc:sldMk cId="109857222" sldId="256"/>
            <ac:picMk id="5" creationId="{E3B3C4B5-98D5-46D9-A423-7CDE1F7D42C9}"/>
          </ac:picMkLst>
        </pc:picChg>
      </pc:sldChg>
      <pc:sldMasterChg chg="modSp del delSldLayout modSldLayout">
        <pc:chgData name="Nudelman, Kelly Nicole Holohan" userId="S::kholohan@iu.edu::bad2640b-c1a5-43c5-b732-fde9e232756e" providerId="AD" clId="Web-{E2A24B24-D6C7-4516-9B7D-7A0CC594BA30}" dt="2022-02-07T14:18:48.040" v="2"/>
        <pc:sldMasterMkLst>
          <pc:docMk/>
          <pc:sldMasterMk cId="2460954070" sldId="2147483660"/>
        </pc:sldMasterMkLst>
        <pc:spChg chg="mod">
          <ac:chgData name="Nudelman, Kelly Nicole Holohan" userId="S::kholohan@iu.edu::bad2640b-c1a5-43c5-b732-fde9e232756e" providerId="AD" clId="Web-{E2A24B24-D6C7-4516-9B7D-7A0CC594BA30}" dt="2022-02-07T14:18:47.962" v="1"/>
          <ac:spMkLst>
            <pc:docMk/>
            <pc:sldMasterMk cId="2460954070" sldId="2147483660"/>
            <ac:spMk id="2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E2A24B24-D6C7-4516-9B7D-7A0CC594BA30}" dt="2022-02-07T14:18:47.962" v="1"/>
          <ac:spMkLst>
            <pc:docMk/>
            <pc:sldMasterMk cId="2460954070" sldId="2147483660"/>
            <ac:spMk id="3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E2A24B24-D6C7-4516-9B7D-7A0CC594BA30}" dt="2022-02-07T14:18:47.962" v="1"/>
          <ac:spMkLst>
            <pc:docMk/>
            <pc:sldMasterMk cId="2460954070" sldId="2147483660"/>
            <ac:spMk id="4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E2A24B24-D6C7-4516-9B7D-7A0CC594BA30}" dt="2022-02-07T14:18:47.962" v="1"/>
          <ac:spMkLst>
            <pc:docMk/>
            <pc:sldMasterMk cId="2460954070" sldId="2147483660"/>
            <ac:spMk id="5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E2A24B24-D6C7-4516-9B7D-7A0CC594BA30}" dt="2022-02-07T14:18:47.962" v="1"/>
          <ac:spMkLst>
            <pc:docMk/>
            <pc:sldMasterMk cId="2460954070" sldId="2147483660"/>
            <ac:spMk id="6" creationId="{00000000-0000-0000-0000-000000000000}"/>
          </ac:spMkLst>
        </pc:sp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2385387890" sldId="2147483661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2385387890" sldId="2147483661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2385387890" sldId="2147483661"/>
              <ac:spMk id="3" creationId="{00000000-0000-0000-0000-000000000000}"/>
            </ac:spMkLst>
          </pc:spChg>
        </pc:sldLayoutChg>
        <pc:sldLayoutChg chg="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949138452" sldId="2147483662"/>
          </pc:sldLayoutMkLst>
        </pc:sldLayout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2591524520" sldId="2147483663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2591524520" sldId="2147483663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2591524520" sldId="2147483663"/>
              <ac:spMk id="3" creationId="{00000000-0000-0000-0000-000000000000}"/>
            </ac:spMkLst>
          </pc:spChg>
        </pc:sldLayout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1203092039" sldId="2147483664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1203092039" sldId="2147483664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1203092039" sldId="2147483664"/>
              <ac:spMk id="4" creationId="{00000000-0000-0000-0000-000000000000}"/>
            </ac:spMkLst>
          </pc:spChg>
        </pc:sldLayout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3733172339" sldId="2147483665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733172339" sldId="2147483665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733172339" sldId="2147483665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733172339" sldId="2147483665"/>
              <ac:spMk id="4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733172339" sldId="2147483665"/>
              <ac:spMk id="5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733172339" sldId="2147483665"/>
              <ac:spMk id="6" creationId="{00000000-0000-0000-0000-000000000000}"/>
            </ac:spMkLst>
          </pc:spChg>
        </pc:sldLayoutChg>
        <pc:sldLayoutChg chg="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3210312558" sldId="2147483666"/>
          </pc:sldLayoutMkLst>
        </pc:sldLayoutChg>
        <pc:sldLayoutChg chg="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3146388984" sldId="2147483667"/>
          </pc:sldLayoutMkLst>
        </pc:sldLayout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3171841454" sldId="2147483668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171841454" sldId="2147483668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171841454" sldId="2147483668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171841454" sldId="2147483668"/>
              <ac:spMk id="4" creationId="{00000000-0000-0000-0000-000000000000}"/>
            </ac:spMkLst>
          </pc:spChg>
        </pc:sldLayout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1718958274" sldId="2147483669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1718958274" sldId="2147483669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1718958274" sldId="2147483669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1718958274" sldId="2147483669"/>
              <ac:spMk id="4" creationId="{00000000-0000-0000-0000-000000000000}"/>
            </ac:spMkLst>
          </pc:spChg>
        </pc:sldLayoutChg>
        <pc:sldLayoutChg chg="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2202905451" sldId="2147483670"/>
          </pc:sldLayoutMkLst>
        </pc:sldLayoutChg>
        <pc:sldLayoutChg chg="modSp del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460954070" sldId="2147483660"/>
            <pc:sldLayoutMk cId="3479445657" sldId="2147483671"/>
          </pc:sldLayoutMkLst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479445657" sldId="2147483671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E2A24B24-D6C7-4516-9B7D-7A0CC594BA30}" dt="2022-02-07T14:18:47.962" v="1"/>
            <ac:spMkLst>
              <pc:docMk/>
              <pc:sldMasterMk cId="2460954070" sldId="2147483660"/>
              <pc:sldLayoutMk cId="3479445657" sldId="2147483671"/>
              <ac:spMk id="3" creationId="{00000000-0000-0000-0000-000000000000}"/>
            </ac:spMkLst>
          </pc:spChg>
        </pc:sldLayoutChg>
      </pc:sldMasterChg>
      <pc:sldMasterChg chg="add addSldLayout modSldLayout">
        <pc:chgData name="Nudelman, Kelly Nicole Holohan" userId="S::kholohan@iu.edu::bad2640b-c1a5-43c5-b732-fde9e232756e" providerId="AD" clId="Web-{E2A24B24-D6C7-4516-9B7D-7A0CC594BA30}" dt="2022-02-07T14:18:48.040" v="2"/>
        <pc:sldMasterMkLst>
          <pc:docMk/>
          <pc:sldMasterMk cId="2283788400" sldId="2147483672"/>
        </pc:sldMasterMkLst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2958271171" sldId="2147483673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3445302773" sldId="2147483674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299489987" sldId="2147483675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3484285200" sldId="2147483676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2085378630" sldId="2147483677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1028134323" sldId="2147483678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3775404689" sldId="2147483679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4292841734" sldId="2147483680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4167952393" sldId="2147483681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586549611" sldId="2147483682"/>
          </pc:sldLayoutMkLst>
        </pc:sldLayoutChg>
        <pc:sldLayoutChg chg="add mod replId">
          <pc:chgData name="Nudelman, Kelly Nicole Holohan" userId="S::kholohan@iu.edu::bad2640b-c1a5-43c5-b732-fde9e232756e" providerId="AD" clId="Web-{E2A24B24-D6C7-4516-9B7D-7A0CC594BA30}" dt="2022-02-07T14:18:48.040" v="2"/>
          <pc:sldLayoutMkLst>
            <pc:docMk/>
            <pc:sldMasterMk cId="2283788400" sldId="2147483672"/>
            <pc:sldLayoutMk cId="2061689794" sldId="2147483683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" y="1197187"/>
            <a:ext cx="3108960" cy="2546773"/>
          </a:xfrm>
        </p:spPr>
        <p:txBody>
          <a:bodyPr anchor="b"/>
          <a:lstStyle>
            <a:lvl1pPr algn="ctr">
              <a:defRPr sz="3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" y="3842174"/>
            <a:ext cx="2743200" cy="1766146"/>
          </a:xfrm>
        </p:spPr>
        <p:txBody>
          <a:bodyPr/>
          <a:lstStyle>
            <a:lvl1pPr marL="0" indent="0" algn="ctr">
              <a:buNone/>
              <a:defRPr sz="1200"/>
            </a:lvl1pPr>
            <a:lvl2pPr marL="228600" indent="0" algn="ctr">
              <a:buNone/>
              <a:defRPr sz="1000"/>
            </a:lvl2pPr>
            <a:lvl3pPr marL="457200" indent="0" algn="ctr">
              <a:buNone/>
              <a:defRPr sz="900"/>
            </a:lvl3pPr>
            <a:lvl4pPr marL="685800" indent="0" algn="ctr">
              <a:buNone/>
              <a:defRPr sz="800"/>
            </a:lvl4pPr>
            <a:lvl5pPr marL="914400" indent="0" algn="ctr">
              <a:buNone/>
              <a:defRPr sz="800"/>
            </a:lvl5pPr>
            <a:lvl6pPr marL="1143000" indent="0" algn="ctr">
              <a:buNone/>
              <a:defRPr sz="800"/>
            </a:lvl6pPr>
            <a:lvl7pPr marL="1371600" indent="0" algn="ctr">
              <a:buNone/>
              <a:defRPr sz="800"/>
            </a:lvl7pPr>
            <a:lvl8pPr marL="1600200" indent="0" algn="ctr">
              <a:buNone/>
              <a:defRPr sz="800"/>
            </a:lvl8pPr>
            <a:lvl9pPr marL="1828800" indent="0" algn="ctr">
              <a:buNone/>
              <a:defRPr sz="8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8271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6549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" y="389467"/>
            <a:ext cx="788670" cy="6199294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" y="389467"/>
            <a:ext cx="2320290" cy="6199294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1689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5302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" y="1823722"/>
            <a:ext cx="3154680" cy="3042919"/>
          </a:xfrm>
        </p:spPr>
        <p:txBody>
          <a:bodyPr anchor="b"/>
          <a:lstStyle>
            <a:lvl1pPr>
              <a:defRPr sz="3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" y="4895429"/>
            <a:ext cx="3154680" cy="1600199"/>
          </a:xfrm>
        </p:spPr>
        <p:txBody>
          <a:bodyPr/>
          <a:lstStyle>
            <a:lvl1pPr marL="0" indent="0">
              <a:buNone/>
              <a:defRPr sz="1200">
                <a:solidFill>
                  <a:schemeClr val="tx1"/>
                </a:solidFill>
              </a:defRPr>
            </a:lvl1pPr>
            <a:lvl2pPr marL="22860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572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685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9144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1430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6002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1828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489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" y="1947333"/>
            <a:ext cx="1554480" cy="46414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" y="1947333"/>
            <a:ext cx="1554480" cy="46414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4285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" y="389468"/>
            <a:ext cx="3154680" cy="1413934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7" y="1793241"/>
            <a:ext cx="1547336" cy="878839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7" y="2672080"/>
            <a:ext cx="1547336" cy="39302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" y="1793241"/>
            <a:ext cx="1554956" cy="878839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" y="2672080"/>
            <a:ext cx="1554956" cy="39302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5378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8134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5404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7" y="487680"/>
            <a:ext cx="1179671" cy="1706880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" y="1053255"/>
            <a:ext cx="1851660" cy="5198533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7" y="2194560"/>
            <a:ext cx="1179671" cy="4065694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284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7" y="487680"/>
            <a:ext cx="1179671" cy="1706880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" y="1053255"/>
            <a:ext cx="1851660" cy="5198533"/>
          </a:xfrm>
        </p:spPr>
        <p:txBody>
          <a:bodyPr anchor="t"/>
          <a:lstStyle>
            <a:lvl1pPr marL="0" indent="0">
              <a:buNone/>
              <a:defRPr sz="1600"/>
            </a:lvl1pPr>
            <a:lvl2pPr marL="228600" indent="0">
              <a:buNone/>
              <a:defRPr sz="1400"/>
            </a:lvl2pPr>
            <a:lvl3pPr marL="457200" indent="0">
              <a:buNone/>
              <a:defRPr sz="1200"/>
            </a:lvl3pPr>
            <a:lvl4pPr marL="685800" indent="0">
              <a:buNone/>
              <a:defRPr sz="1000"/>
            </a:lvl4pPr>
            <a:lvl5pPr marL="914400" indent="0">
              <a:buNone/>
              <a:defRPr sz="1000"/>
            </a:lvl5pPr>
            <a:lvl6pPr marL="1143000" indent="0">
              <a:buNone/>
              <a:defRPr sz="1000"/>
            </a:lvl6pPr>
            <a:lvl7pPr marL="1371600" indent="0">
              <a:buNone/>
              <a:defRPr sz="1000"/>
            </a:lvl7pPr>
            <a:lvl8pPr marL="1600200" indent="0">
              <a:buNone/>
              <a:defRPr sz="1000"/>
            </a:lvl8pPr>
            <a:lvl9pPr marL="1828800" indent="0">
              <a:buNone/>
              <a:defRPr sz="1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7" y="2194560"/>
            <a:ext cx="1179671" cy="4065694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7952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" y="389468"/>
            <a:ext cx="315468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" y="1947333"/>
            <a:ext cx="315468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" y="6780108"/>
            <a:ext cx="8229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5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" y="6780108"/>
            <a:ext cx="123444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" y="6780108"/>
            <a:ext cx="8229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3788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Chart, line chart&#10;&#10;Description automatically generated">
            <a:extLst>
              <a:ext uri="{FF2B5EF4-FFF2-40B4-BE49-F238E27FC236}">
                <a16:creationId xmlns:a16="http://schemas.microsoft.com/office/drawing/2014/main" xmlns="" id="{30413DD4-CBF8-4C02-B6F5-D20E315B91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024" y="169295"/>
            <a:ext cx="3313744" cy="3385062"/>
          </a:xfrm>
          <a:prstGeom prst="rect">
            <a:avLst/>
          </a:prstGeom>
        </p:spPr>
      </p:pic>
      <p:pic>
        <p:nvPicPr>
          <p:cNvPr id="5" name="Picture 5" descr="Chart, line chart&#10;&#10;Description automatically generated">
            <a:extLst>
              <a:ext uri="{FF2B5EF4-FFF2-40B4-BE49-F238E27FC236}">
                <a16:creationId xmlns:a16="http://schemas.microsoft.com/office/drawing/2014/main" xmlns="" id="{E3B3C4B5-98D5-46D9-A423-7CDE1F7D42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372" y="3712228"/>
            <a:ext cx="3303556" cy="3385061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xmlns="" id="{614DAAE1-C538-4839-B905-9E9A300CB36D}"/>
              </a:ext>
            </a:extLst>
          </p:cNvPr>
          <p:cNvSpPr txBox="1"/>
          <p:nvPr/>
        </p:nvSpPr>
        <p:spPr>
          <a:xfrm>
            <a:off x="-4033" y="33138"/>
            <a:ext cx="688560" cy="276999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dirty="0">
                <a:latin typeface="Arial"/>
                <a:cs typeface="Arial"/>
              </a:rPr>
              <a:t>A)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xmlns="" id="{36261306-873B-444B-A42B-FAF44FB8BA76}"/>
              </a:ext>
            </a:extLst>
          </p:cNvPr>
          <p:cNvSpPr txBox="1"/>
          <p:nvPr/>
        </p:nvSpPr>
        <p:spPr>
          <a:xfrm>
            <a:off x="-4034" y="3554893"/>
            <a:ext cx="688560" cy="276999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dirty="0">
                <a:latin typeface="Arial"/>
                <a:cs typeface="Arial"/>
              </a:rPr>
              <a:t>B)</a:t>
            </a: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xmlns="" id="{B1CF2514-160D-4953-9AE9-15296A6BCD56}"/>
              </a:ext>
            </a:extLst>
          </p:cNvPr>
          <p:cNvSpPr txBox="1"/>
          <p:nvPr/>
        </p:nvSpPr>
        <p:spPr>
          <a:xfrm>
            <a:off x="571209" y="33138"/>
            <a:ext cx="2974135" cy="461665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APE Domain Cognitive Performance: SNP X Cancer Case/Control</a:t>
            </a:r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xmlns="" id="{CF53D5A3-59EA-4C53-9ADA-B1179618D15D}"/>
              </a:ext>
            </a:extLst>
          </p:cNvPr>
          <p:cNvSpPr txBox="1"/>
          <p:nvPr/>
        </p:nvSpPr>
        <p:spPr>
          <a:xfrm>
            <a:off x="571208" y="3554893"/>
            <a:ext cx="2862064" cy="461665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/>
                <a:cs typeface="Arial"/>
              </a:rPr>
              <a:t>LM </a:t>
            </a:r>
            <a:r>
              <a:rPr lang="en-US" sz="1200" b="1" dirty="0">
                <a:latin typeface="Arial"/>
                <a:cs typeface="Arial"/>
              </a:rPr>
              <a:t>Domain Cognitive Performance: SNP X Cancer Case/Control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UIDATA" val="&lt;database version=&quot;9.0&quot;&gt;&lt;object type=&quot;1&quot; unique_id=&quot;10001&quot;&gt;&lt;object type=&quot;2&quot; unique_id=&quot;10002&quot;&gt;&lt;object type=&quot;3&quot; unique_id=&quot;10003&quot;&gt;&lt;property id=&quot;20148&quot; value=&quot;5&quot;/&gt;&lt;property id=&quot;20300&quot; value=&quot;Slide 1&quot;/&gt;&lt;property id=&quot;20307&quot; value=&quot;256&quot;/&gt;&lt;/object&gt;&lt;/object&gt;&lt;object type=&quot;8&quot; unique_id=&quot;10006&quot;&gt;&lt;/object&gt;&lt;/object&gt;&lt;/database&gt;"/>
  <p:tag name="MMPROD_NEXTUNIQUEID" val="10009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KNudelman</cp:lastModifiedBy>
  <cp:revision>24</cp:revision>
  <dcterms:created xsi:type="dcterms:W3CDTF">2022-02-07T14:08:22Z</dcterms:created>
  <dcterms:modified xsi:type="dcterms:W3CDTF">2022-05-23T20:28:40Z</dcterms:modified>
</cp:coreProperties>
</file>